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5"/>
    <p:restoredTop sz="94673"/>
  </p:normalViewPr>
  <p:slideViewPr>
    <p:cSldViewPr snapToGrid="0" snapToObjects="1" showGuides="1">
      <p:cViewPr varScale="1">
        <p:scale>
          <a:sx n="158" d="100"/>
          <a:sy n="158" d="100"/>
        </p:scale>
        <p:origin x="200" y="4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F80839-963F-0E49-8661-EA13B1580B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19411ED-6BAF-6D4E-AE58-56C2154C39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05F101-66C3-5349-8B34-3CEB2CE7D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804AC5-554D-BF4C-B297-6EB161FB2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9DF3F2-420E-9440-BC15-ED1BD876A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714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998CA8-76CF-4742-96AE-2B47535EB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3FFCECA-32A6-BF4E-8203-EB8BF7C31D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5F21CB-865E-0E42-A721-D88A247DE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7BFA08-DDAC-EE46-B2F0-7C13E10F5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516268-3802-C848-8C89-FC69F8FAC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8914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D5AD012-D274-DB4D-95D2-62D09B0735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772A3D5-8089-FA41-A45E-DBA5C48D5E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1BC43D-2DD5-B24C-B92F-559109152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E948BA6-C246-AB4F-9C6B-993F21568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8CD006-5103-0F4F-92E8-198805942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508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D79538-59CE-5240-93B7-EE30E82F5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EC471A9-F1A8-6A48-A53D-A2B2027C79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F75A5A-7E8C-3241-93BB-2F981DB7B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343A1F-56F0-394F-82D0-1CE95A35C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BDD1AE-814A-7D43-A370-DBA1AA043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3889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F11136-54B9-E24A-A07A-E8516E090A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77E408C-1E24-2344-B7B2-B2B3A782D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23D762-3564-CA42-8B18-5B7B5F45D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5224D6-CEFA-124E-A2F3-B683C13BA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45DE7B7-1B14-0945-9976-53FC16A98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57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789046-E42F-FD44-ADA0-28ECCB0F2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50EB9D-A582-794C-B018-B0D8F18754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742DF92-02C9-5843-BF9F-C2CEF8AE4F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748289-D002-6742-BC07-81EDC8425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78707D-B81A-A048-A3C3-8FF65F226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B071E02-37D9-4045-B357-1034454D5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9975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7390C6-75EC-C647-83E2-5CB6E07A81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82386B-1F43-F248-BB32-FF167FF545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2E634F1-7767-994A-9DB5-3B7D04A179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C0A66D0-C50B-1140-9127-BF99E382A2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F16556F-A4B0-AC48-90D1-A7C5C81B69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11CB77D-03CC-B341-BFE5-B03F6005E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DF79877-1FEF-A448-9EF0-C1347C35C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B0BB5A2-93E3-0D4C-99B5-BB1662C12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978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724F3A-7960-A640-9516-D6CDDE5C72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DD54285-42BA-A44E-8602-FCEAB4027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86B9D7F-5B37-AC4B-AB72-BC37860D8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6EA7AD-5F07-2448-A028-F15E91137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0432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175DE51-FA63-2C4B-953B-81F4DC26E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38ECAB5-4650-E84A-A8C8-3375057F6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D76D5DE-5D7E-4048-ACD2-CA5E2E038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4198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87BE49-0F5A-194F-9D23-3E403CA1D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507F38-6B89-2F4E-96E8-8E74D29FE7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8AFB398-5C54-9A42-9D1B-F726D7E2D7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50422A-31C7-7F4D-91C7-BED80B294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4EBD47A-4ED9-BB4A-A13E-9A9AA4B91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C44D27-FF12-D042-8C7F-347DC563D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034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F920D8-B60C-A24A-AB89-C9CBC734B6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6AFCE9C-4FFC-1D4F-A2CD-FDF9F74832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89C9C78-F7B0-D54C-8644-98F4CA567E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85000AC-D7CB-2D45-A3DE-64E7B4621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18477A6-C227-0641-A3DD-EFA4D41E2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D5F8C8B-70C9-5C4C-B91C-A41611963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989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9D4BF6D-6B68-4B48-BC19-4CCE6540C3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962942-CED3-664C-9279-56792BEF3B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AD0AE5-BEB7-CF47-ABBC-981276EE30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430BC-6A3B-C24F-BA77-34C08D6B061D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32EC6A0-0B9B-1848-A1CE-0DF164398B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DEBD7C-C93F-F544-8184-8041BDD841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3ED73-3ECF-2641-92E3-EE4E999654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41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0ABD014-E00D-3948-8571-6BAE0DD877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9203" y="1556762"/>
            <a:ext cx="4855985" cy="3568210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2BD7B75-1B2D-6B47-9A38-E81C21954122}"/>
              </a:ext>
            </a:extLst>
          </p:cNvPr>
          <p:cNvSpPr/>
          <p:nvPr/>
        </p:nvSpPr>
        <p:spPr>
          <a:xfrm>
            <a:off x="701310" y="749564"/>
            <a:ext cx="523824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1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kumimoji="0" lang="en-US" altLang="ja-JP" sz="11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0" lang="ja-JP" altLang="ja-JP" sz="11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0" lang="en-US" altLang="ja-JP" sz="11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tro virus infection of mouse CD39 into EG7-OVA </a:t>
            </a:r>
            <a:r>
              <a:rPr kumimoji="0" lang="ja-JP" altLang="ja-JP" sz="1100" b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1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uman T cell lymphoma cell line.</a:t>
            </a:r>
            <a:endParaRPr kumimoji="0" lang="ja-JP" altLang="ja-JP" sz="11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8B0032B-B5B8-8946-BC67-C8A0967D4E83}"/>
              </a:ext>
            </a:extLst>
          </p:cNvPr>
          <p:cNvSpPr txBox="1"/>
          <p:nvPr/>
        </p:nvSpPr>
        <p:spPr>
          <a:xfrm>
            <a:off x="701310" y="5446707"/>
            <a:ext cx="552146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was used to examine CD39 expression in the GFP-positive fraction of CD39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fected cells, and in mock transfected cells. The GFP-positive cells were selected using a FACS cell sorter and were used in the following experiments.</a:t>
            </a:r>
            <a:r>
              <a:rPr lang="ja-JP" altLang="ja-JP" sz="11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0466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60</Words>
  <Application>Microsoft Macintosh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柴山 幸子</dc:creator>
  <cp:lastModifiedBy>柴山 幸子</cp:lastModifiedBy>
  <cp:revision>2</cp:revision>
  <dcterms:created xsi:type="dcterms:W3CDTF">2019-12-23T13:32:38Z</dcterms:created>
  <dcterms:modified xsi:type="dcterms:W3CDTF">2019-12-23T14:43:58Z</dcterms:modified>
</cp:coreProperties>
</file>